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87"/>
    <p:restoredTop sz="94686"/>
  </p:normalViewPr>
  <p:slideViewPr>
    <p:cSldViewPr snapToGrid="0" snapToObjects="1">
      <p:cViewPr varScale="1">
        <p:scale>
          <a:sx n="79" d="100"/>
          <a:sy n="79" d="100"/>
        </p:scale>
        <p:origin x="168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5F2A2-9882-8147-9D60-90CC20B6E9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F486C-8824-424D-BB94-02F018289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1343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5F2A2-9882-8147-9D60-90CC20B6E9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F486C-8824-424D-BB94-02F018289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7775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5F2A2-9882-8147-9D60-90CC20B6E9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F486C-8824-424D-BB94-02F018289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032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5F2A2-9882-8147-9D60-90CC20B6E9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F486C-8824-424D-BB94-02F018289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5364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5F2A2-9882-8147-9D60-90CC20B6E9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F486C-8824-424D-BB94-02F018289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334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5F2A2-9882-8147-9D60-90CC20B6E9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F486C-8824-424D-BB94-02F018289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7207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5F2A2-9882-8147-9D60-90CC20B6E9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F486C-8824-424D-BB94-02F018289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3599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5F2A2-9882-8147-9D60-90CC20B6E9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F486C-8824-424D-BB94-02F018289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474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5F2A2-9882-8147-9D60-90CC20B6E9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F486C-8824-424D-BB94-02F018289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8026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5F2A2-9882-8147-9D60-90CC20B6E9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F486C-8824-424D-BB94-02F018289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1436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5F2A2-9882-8147-9D60-90CC20B6E9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F486C-8824-424D-BB94-02F018289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1147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75F2A2-9882-8147-9D60-90CC20B6E9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9F486C-8824-424D-BB94-02F018289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8903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3" Type="http://schemas.openxmlformats.org/officeDocument/2006/relationships/oleObject" Target="../embeddings/oleObject1.bin"/><Relationship Id="rId7" Type="http://schemas.openxmlformats.org/officeDocument/2006/relationships/image" Target="../media/image4.jpe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jpeg"/><Relationship Id="rId5" Type="http://schemas.openxmlformats.org/officeDocument/2006/relationships/image" Target="../media/image2.jpeg"/><Relationship Id="rId4" Type="http://schemas.openxmlformats.org/officeDocument/2006/relationships/image" Target="../media/image1.emf"/><Relationship Id="rId9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>
            <a:extLst>
              <a:ext uri="{FF2B5EF4-FFF2-40B4-BE49-F238E27FC236}">
                <a16:creationId xmlns:a16="http://schemas.microsoft.com/office/drawing/2014/main" id="{1BA7A3FB-81CA-914B-9D8F-BE36F133AE5D}"/>
              </a:ext>
            </a:extLst>
          </p:cNvPr>
          <p:cNvGrpSpPr/>
          <p:nvPr/>
        </p:nvGrpSpPr>
        <p:grpSpPr>
          <a:xfrm>
            <a:off x="506187" y="642011"/>
            <a:ext cx="6858000" cy="8676485"/>
            <a:chOff x="506187" y="645949"/>
            <a:chExt cx="6858000" cy="8676485"/>
          </a:xfrm>
        </p:grpSpPr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AE2A41D2-4B2B-E44B-B428-ACDCC22A3B52}"/>
                </a:ext>
              </a:extLst>
            </p:cNvPr>
            <p:cNvGrpSpPr/>
            <p:nvPr/>
          </p:nvGrpSpPr>
          <p:grpSpPr>
            <a:xfrm>
              <a:off x="506187" y="645949"/>
              <a:ext cx="6858000" cy="8676485"/>
              <a:chOff x="506187" y="645949"/>
              <a:chExt cx="6858000" cy="8676485"/>
            </a:xfrm>
          </p:grpSpPr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BAE256A2-BDF7-2041-9666-5988AE1010A4}"/>
                  </a:ext>
                </a:extLst>
              </p:cNvPr>
              <p:cNvGrpSpPr/>
              <p:nvPr/>
            </p:nvGrpSpPr>
            <p:grpSpPr>
              <a:xfrm>
                <a:off x="506187" y="645949"/>
                <a:ext cx="6858000" cy="8676485"/>
                <a:chOff x="506187" y="678606"/>
                <a:chExt cx="6858000" cy="8676485"/>
              </a:xfrm>
            </p:grpSpPr>
            <p:sp>
              <p:nvSpPr>
                <p:cNvPr id="4" name="TextBox 3">
                  <a:extLst>
                    <a:ext uri="{FF2B5EF4-FFF2-40B4-BE49-F238E27FC236}">
                      <a16:creationId xmlns:a16="http://schemas.microsoft.com/office/drawing/2014/main" id="{0CBCE182-5ABD-DD4A-9440-D45F4C9315DE}"/>
                    </a:ext>
                  </a:extLst>
                </p:cNvPr>
                <p:cNvSpPr txBox="1"/>
                <p:nvPr/>
              </p:nvSpPr>
              <p:spPr>
                <a:xfrm>
                  <a:off x="667655" y="678606"/>
                  <a:ext cx="646267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Figure 2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aphicFrame>
              <p:nvGraphicFramePr>
                <p:cNvPr id="5" name="Object 4">
                  <a:extLst>
                    <a:ext uri="{FF2B5EF4-FFF2-40B4-BE49-F238E27FC236}">
                      <a16:creationId xmlns:a16="http://schemas.microsoft.com/office/drawing/2014/main" id="{7C61EB5D-74FE-854F-8323-997276FFF4C8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794331670"/>
                    </p:ext>
                  </p:extLst>
                </p:nvPr>
              </p:nvGraphicFramePr>
              <p:xfrm>
                <a:off x="506187" y="976981"/>
                <a:ext cx="6858000" cy="255211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028" name="Prism 6" r:id="rId3" imgW="9492097" imgH="3532751" progId="Prism6.Document">
                        <p:embed/>
                      </p:oleObj>
                    </mc:Choice>
                    <mc:Fallback>
                      <p:oleObj name="Prism 6" r:id="rId3" imgW="9492097" imgH="3532751" progId="Prism6.Document">
                        <p:embed/>
                        <p:pic>
                          <p:nvPicPr>
                            <p:cNvPr id="5" name="Object 4">
                              <a:extLst>
                                <a:ext uri="{FF2B5EF4-FFF2-40B4-BE49-F238E27FC236}">
                                  <a16:creationId xmlns:a16="http://schemas.microsoft.com/office/drawing/2014/main" id="{7C61EB5D-74FE-854F-8323-997276FFF4C8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4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06187" y="976981"/>
                              <a:ext cx="6858000" cy="255211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14" name="Group 13">
                  <a:extLst>
                    <a:ext uri="{FF2B5EF4-FFF2-40B4-BE49-F238E27FC236}">
                      <a16:creationId xmlns:a16="http://schemas.microsoft.com/office/drawing/2014/main" id="{90CABE5F-8695-744D-A202-65747E758AE3}"/>
                    </a:ext>
                  </a:extLst>
                </p:cNvPr>
                <p:cNvGrpSpPr/>
                <p:nvPr/>
              </p:nvGrpSpPr>
              <p:grpSpPr>
                <a:xfrm>
                  <a:off x="642074" y="3426851"/>
                  <a:ext cx="6488253" cy="3474721"/>
                  <a:chOff x="749300" y="3459509"/>
                  <a:chExt cx="6488253" cy="3474721"/>
                </a:xfrm>
              </p:grpSpPr>
              <p:grpSp>
                <p:nvGrpSpPr>
                  <p:cNvPr id="9" name="Group 8">
                    <a:extLst>
                      <a:ext uri="{FF2B5EF4-FFF2-40B4-BE49-F238E27FC236}">
                        <a16:creationId xmlns:a16="http://schemas.microsoft.com/office/drawing/2014/main" id="{2D2A8584-982E-204D-9FF5-67994E4CC2CC}"/>
                      </a:ext>
                    </a:extLst>
                  </p:cNvPr>
                  <p:cNvGrpSpPr/>
                  <p:nvPr/>
                </p:nvGrpSpPr>
                <p:grpSpPr>
                  <a:xfrm>
                    <a:off x="749300" y="3459509"/>
                    <a:ext cx="6488253" cy="3474721"/>
                    <a:chOff x="749300" y="3573812"/>
                    <a:chExt cx="6488253" cy="3474721"/>
                  </a:xfrm>
                </p:grpSpPr>
                <p:grpSp>
                  <p:nvGrpSpPr>
                    <p:cNvPr id="2" name="Group 1">
                      <a:extLst>
                        <a:ext uri="{FF2B5EF4-FFF2-40B4-BE49-F238E27FC236}">
                          <a16:creationId xmlns:a16="http://schemas.microsoft.com/office/drawing/2014/main" id="{AA5FA63D-ADB7-044B-8F28-3CF6CC12272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749302" y="3573812"/>
                      <a:ext cx="6488250" cy="3474721"/>
                      <a:chOff x="749302" y="3573812"/>
                      <a:chExt cx="6488250" cy="3474721"/>
                    </a:xfrm>
                  </p:grpSpPr>
                  <p:pic>
                    <p:nvPicPr>
                      <p:cNvPr id="6" name="Picture 5" descr="8721 F480 3.tif">
                        <a:extLst>
                          <a:ext uri="{FF2B5EF4-FFF2-40B4-BE49-F238E27FC236}">
                            <a16:creationId xmlns:a16="http://schemas.microsoft.com/office/drawing/2014/main" id="{15EB83D7-CC02-7F4C-B238-0A8CE4CAC647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5" cstate="email">
                        <a:clrChange>
                          <a:clrFrom>
                            <a:srgbClr val="FCFAE9"/>
                          </a:clrFrom>
                          <a:clrTo>
                            <a:srgbClr val="FCFAE9">
                              <a:alpha val="0"/>
                            </a:srgbClr>
                          </a:clrTo>
                        </a:clrChange>
                        <a:extLst>
                          <a:ext uri="{28A0092B-C50C-407E-A947-70E740481C1C}">
                            <a14:useLocalDpi xmlns:a14="http://schemas.microsoft.com/office/drawing/2010/main"/>
                          </a:ext>
                        </a:extLst>
                      </a:blip>
                      <a:srcRect/>
                      <a:stretch/>
                    </p:blipFill>
                    <p:spPr>
                      <a:xfrm rot="16200000">
                        <a:off x="-7436" y="4330550"/>
                        <a:ext cx="3474720" cy="1961244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7" name="Picture 6" descr="8774 F480.tif">
                        <a:extLst>
                          <a:ext uri="{FF2B5EF4-FFF2-40B4-BE49-F238E27FC236}">
                            <a16:creationId xmlns:a16="http://schemas.microsoft.com/office/drawing/2014/main" id="{C621693D-B882-0748-97D9-868C5535DCD4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6" cstate="email">
                        <a:extLst>
                          <a:ext uri="{28A0092B-C50C-407E-A947-70E740481C1C}">
                            <a14:useLocalDpi xmlns:a14="http://schemas.microsoft.com/office/drawing/2010/main"/>
                          </a:ext>
                        </a:extLst>
                      </a:blip>
                      <a:srcRect/>
                      <a:stretch/>
                    </p:blipFill>
                    <p:spPr>
                      <a:xfrm flipH="1">
                        <a:off x="2756067" y="3786089"/>
                        <a:ext cx="2286002" cy="3234346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8" name="Picture 7" descr="8781 F480.tif">
                        <a:extLst>
                          <a:ext uri="{FF2B5EF4-FFF2-40B4-BE49-F238E27FC236}">
                            <a16:creationId xmlns:a16="http://schemas.microsoft.com/office/drawing/2014/main" id="{5CFC38C4-4A3A-244D-8CEA-DA86ADF77DFB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7" cstate="email">
                        <a:extLst>
                          <a:ext uri="{28A0092B-C50C-407E-A947-70E740481C1C}">
                            <a14:useLocalDpi xmlns:a14="http://schemas.microsoft.com/office/drawing/2010/main"/>
                          </a:ext>
                        </a:extLst>
                      </a:blip>
                      <a:srcRect/>
                      <a:stretch/>
                    </p:blipFill>
                    <p:spPr>
                      <a:xfrm rot="16200000">
                        <a:off x="4402451" y="4213431"/>
                        <a:ext cx="3474720" cy="2195483"/>
                      </a:xfrm>
                      <a:prstGeom prst="rect">
                        <a:avLst/>
                      </a:prstGeom>
                    </p:spPr>
                  </p:pic>
                </p:grpSp>
                <p:sp>
                  <p:nvSpPr>
                    <p:cNvPr id="3" name="Rectangle 2">
                      <a:extLst>
                        <a:ext uri="{FF2B5EF4-FFF2-40B4-BE49-F238E27FC236}">
                          <a16:creationId xmlns:a16="http://schemas.microsoft.com/office/drawing/2014/main" id="{0DDFEA86-CDD9-7846-81CC-9131F208B9C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9300" y="3573812"/>
                      <a:ext cx="6488253" cy="3474720"/>
                    </a:xfrm>
                    <a:prstGeom prst="rect">
                      <a:avLst/>
                    </a:prstGeom>
                    <a:noFill/>
                    <a:ln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  <p:sp>
                <p:nvSpPr>
                  <p:cNvPr id="10" name="TextBox 9">
                    <a:extLst>
                      <a:ext uri="{FF2B5EF4-FFF2-40B4-BE49-F238E27FC236}">
                        <a16:creationId xmlns:a16="http://schemas.microsoft.com/office/drawing/2014/main" id="{AA7E8571-C698-2347-8A65-736EC1413708}"/>
                      </a:ext>
                    </a:extLst>
                  </p:cNvPr>
                  <p:cNvSpPr txBox="1"/>
                  <p:nvPr/>
                </p:nvSpPr>
                <p:spPr>
                  <a:xfrm>
                    <a:off x="769096" y="3470791"/>
                    <a:ext cx="314510" cy="307777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</a:p>
                </p:txBody>
              </p:sp>
              <p:sp>
                <p:nvSpPr>
                  <p:cNvPr id="11" name="TextBox 10">
                    <a:extLst>
                      <a:ext uri="{FF2B5EF4-FFF2-40B4-BE49-F238E27FC236}">
                        <a16:creationId xmlns:a16="http://schemas.microsoft.com/office/drawing/2014/main" id="{24190CD8-4B02-3449-97D6-D537F3B23A25}"/>
                      </a:ext>
                    </a:extLst>
                  </p:cNvPr>
                  <p:cNvSpPr txBox="1"/>
                  <p:nvPr/>
                </p:nvSpPr>
                <p:spPr>
                  <a:xfrm>
                    <a:off x="4976591" y="3470791"/>
                    <a:ext cx="304892" cy="307777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</a:t>
                    </a:r>
                  </a:p>
                </p:txBody>
              </p:sp>
              <p:sp>
                <p:nvSpPr>
                  <p:cNvPr id="12" name="TextBox 11">
                    <a:extLst>
                      <a:ext uri="{FF2B5EF4-FFF2-40B4-BE49-F238E27FC236}">
                        <a16:creationId xmlns:a16="http://schemas.microsoft.com/office/drawing/2014/main" id="{76EE2322-EDEB-934E-83F2-A3F200CA4171}"/>
                      </a:ext>
                    </a:extLst>
                  </p:cNvPr>
                  <p:cNvSpPr txBox="1"/>
                  <p:nvPr/>
                </p:nvSpPr>
                <p:spPr>
                  <a:xfrm>
                    <a:off x="2771007" y="3470791"/>
                    <a:ext cx="314510" cy="307777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</a:t>
                    </a:r>
                  </a:p>
                </p:txBody>
              </p:sp>
              <p:sp>
                <p:nvSpPr>
                  <p:cNvPr id="13" name="Rectangle 12">
                    <a:extLst>
                      <a:ext uri="{FF2B5EF4-FFF2-40B4-BE49-F238E27FC236}">
                        <a16:creationId xmlns:a16="http://schemas.microsoft.com/office/drawing/2014/main" id="{0CBF0476-704B-4144-8E50-F7D6A1D7D5A0}"/>
                      </a:ext>
                    </a:extLst>
                  </p:cNvPr>
                  <p:cNvSpPr/>
                  <p:nvPr/>
                </p:nvSpPr>
                <p:spPr>
                  <a:xfrm>
                    <a:off x="2771007" y="3459509"/>
                    <a:ext cx="2240280" cy="3474720"/>
                  </a:xfrm>
                  <a:prstGeom prst="rect">
                    <a:avLst/>
                  </a:prstGeom>
                  <a:noFill/>
                  <a:ln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pic>
              <p:nvPicPr>
                <p:cNvPr id="15" name="Picture 14" descr="8781 root 40.tif">
                  <a:extLst>
                    <a:ext uri="{FF2B5EF4-FFF2-40B4-BE49-F238E27FC236}">
                      <a16:creationId xmlns:a16="http://schemas.microsoft.com/office/drawing/2014/main" id="{5E409905-1DCD-9849-A813-F18F5E78DDC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52033" y="6950853"/>
                  <a:ext cx="3200400" cy="2400300"/>
                </a:xfrm>
                <a:prstGeom prst="rect">
                  <a:avLst/>
                </a:prstGeom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</p:pic>
            <p:pic>
              <p:nvPicPr>
                <p:cNvPr id="16" name="Picture 15" descr="8790 root.tif">
                  <a:extLst>
                    <a:ext uri="{FF2B5EF4-FFF2-40B4-BE49-F238E27FC236}">
                      <a16:creationId xmlns:a16="http://schemas.microsoft.com/office/drawing/2014/main" id="{1622DFC5-AC71-5E47-BCA4-0267F868DFA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 rot="10800000">
                  <a:off x="3931557" y="6954791"/>
                  <a:ext cx="3200400" cy="2400300"/>
                </a:xfrm>
                <a:prstGeom prst="rect">
                  <a:avLst/>
                </a:prstGeom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</p:pic>
          </p:grp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CEF809E0-A6E7-C14F-BFEE-C5E5E0AFBAC3}"/>
                  </a:ext>
                </a:extLst>
              </p:cNvPr>
              <p:cNvSpPr txBox="1"/>
              <p:nvPr/>
            </p:nvSpPr>
            <p:spPr>
              <a:xfrm>
                <a:off x="658403" y="6924863"/>
                <a:ext cx="293670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830F2762-5813-6A47-929A-0CDC3E709326}"/>
                  </a:ext>
                </a:extLst>
              </p:cNvPr>
              <p:cNvSpPr txBox="1"/>
              <p:nvPr/>
            </p:nvSpPr>
            <p:spPr>
              <a:xfrm>
                <a:off x="3931556" y="6926694"/>
                <a:ext cx="324128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</a:p>
            </p:txBody>
          </p: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A1208A23-59CB-7D47-9771-A1C97373B470}"/>
                </a:ext>
              </a:extLst>
            </p:cNvPr>
            <p:cNvGrpSpPr/>
            <p:nvPr/>
          </p:nvGrpSpPr>
          <p:grpSpPr>
            <a:xfrm>
              <a:off x="651600" y="1132823"/>
              <a:ext cx="3612891" cy="307777"/>
              <a:chOff x="651600" y="1132823"/>
              <a:chExt cx="3612891" cy="307777"/>
            </a:xfrm>
          </p:grpSpPr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504B50CB-1775-8A4B-90FE-EF1467DB463B}"/>
                  </a:ext>
                </a:extLst>
              </p:cNvPr>
              <p:cNvSpPr txBox="1"/>
              <p:nvPr/>
            </p:nvSpPr>
            <p:spPr>
              <a:xfrm>
                <a:off x="651600" y="1132823"/>
                <a:ext cx="314510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41DDDCBA-7E86-AB41-A5BC-DF93A52EFA4D}"/>
                  </a:ext>
                </a:extLst>
              </p:cNvPr>
              <p:cNvSpPr txBox="1"/>
              <p:nvPr/>
            </p:nvSpPr>
            <p:spPr>
              <a:xfrm>
                <a:off x="3949981" y="1132823"/>
                <a:ext cx="314510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CF327025-1685-42F0-8C4A-D7E07BEED45B}"/>
              </a:ext>
            </a:extLst>
          </p:cNvPr>
          <p:cNvSpPr txBox="1"/>
          <p:nvPr/>
        </p:nvSpPr>
        <p:spPr>
          <a:xfrm>
            <a:off x="1948400" y="3405476"/>
            <a:ext cx="812622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i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US" sz="9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jejuni</a:t>
            </a:r>
            <a:r>
              <a:rPr lang="en-US" sz="9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HB93-13</a:t>
            </a:r>
          </a:p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CIgG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E1EB12A-FEA0-47A2-8258-09421079F121}"/>
              </a:ext>
            </a:extLst>
          </p:cNvPr>
          <p:cNvSpPr txBox="1"/>
          <p:nvPr/>
        </p:nvSpPr>
        <p:spPr>
          <a:xfrm>
            <a:off x="4070002" y="3390255"/>
            <a:ext cx="938723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i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US" sz="9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jejuni</a:t>
            </a:r>
            <a:r>
              <a:rPr lang="en-US" sz="9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HB93-13</a:t>
            </a:r>
          </a:p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with anti-IL-4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D503066-6232-496B-89B2-BDC16D27F1A0}"/>
              </a:ext>
            </a:extLst>
          </p:cNvPr>
          <p:cNvSpPr txBox="1"/>
          <p:nvPr/>
        </p:nvSpPr>
        <p:spPr>
          <a:xfrm>
            <a:off x="6495916" y="3372113"/>
            <a:ext cx="6763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i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US" sz="9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jejuni</a:t>
            </a:r>
            <a:r>
              <a:rPr lang="en-US" sz="9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11168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E966249-FDB9-41C3-9A06-5A80ED51D60F}"/>
              </a:ext>
            </a:extLst>
          </p:cNvPr>
          <p:cNvSpPr txBox="1"/>
          <p:nvPr/>
        </p:nvSpPr>
        <p:spPr>
          <a:xfrm>
            <a:off x="2759522" y="6863245"/>
            <a:ext cx="12650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i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US" sz="9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jejuni</a:t>
            </a:r>
            <a:r>
              <a:rPr lang="en-US" sz="9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HB93-13</a:t>
            </a:r>
          </a:p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CIgG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C2855E2-9A11-4AE0-82F9-2CEDE29E8BEE}"/>
              </a:ext>
            </a:extLst>
          </p:cNvPr>
          <p:cNvSpPr txBox="1"/>
          <p:nvPr/>
        </p:nvSpPr>
        <p:spPr>
          <a:xfrm>
            <a:off x="6098820" y="6897073"/>
            <a:ext cx="12650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i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US" sz="9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jejuni</a:t>
            </a:r>
            <a:r>
              <a:rPr lang="en-US" sz="9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HB93-13</a:t>
            </a:r>
          </a:p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with anti-IL-4 </a:t>
            </a:r>
          </a:p>
        </p:txBody>
      </p:sp>
    </p:spTree>
    <p:extLst>
      <p:ext uri="{BB962C8B-B14F-4D97-AF65-F5344CB8AC3E}">
        <p14:creationId xmlns:p14="http://schemas.microsoft.com/office/powerpoint/2010/main" val="17742816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</TotalTime>
  <Words>37</Words>
  <Application>Microsoft Macintosh PowerPoint</Application>
  <PresentationFormat>Custom</PresentationFormat>
  <Paragraphs>17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6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sfield, Linda</dc:creator>
  <cp:lastModifiedBy>Mansfield, Linda</cp:lastModifiedBy>
  <cp:revision>8</cp:revision>
  <dcterms:created xsi:type="dcterms:W3CDTF">2021-06-15T00:40:27Z</dcterms:created>
  <dcterms:modified xsi:type="dcterms:W3CDTF">2022-02-23T23:46:10Z</dcterms:modified>
</cp:coreProperties>
</file>